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sldIdLst>
    <p:sldId id="258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3" autoAdjust="0"/>
    <p:restoredTop sz="94660"/>
  </p:normalViewPr>
  <p:slideViewPr>
    <p:cSldViewPr snapToGrid="0">
      <p:cViewPr varScale="1">
        <p:scale>
          <a:sx n="87" d="100"/>
          <a:sy n="87" d="100"/>
        </p:scale>
        <p:origin x="432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85D114-8123-4FB6-9648-174C608AB846}" type="datetimeFigureOut">
              <a:rPr lang="en-US" smtClean="0"/>
              <a:t>5/1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6B6F8E7-DE09-40C2-ACBB-2BDDC626F3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03209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55877F-DC37-4587-87C2-17AE81D96818}" type="datetimeFigureOut">
              <a:rPr lang="en-US" smtClean="0"/>
              <a:t>5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AA87E-718E-4183-B2A6-27F50425D9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10789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55877F-DC37-4587-87C2-17AE81D96818}" type="datetimeFigureOut">
              <a:rPr lang="en-US" smtClean="0"/>
              <a:t>5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AA87E-718E-4183-B2A6-27F50425D9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93159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55877F-DC37-4587-87C2-17AE81D96818}" type="datetimeFigureOut">
              <a:rPr lang="en-US" smtClean="0"/>
              <a:t>5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AA87E-718E-4183-B2A6-27F50425D9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83009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55877F-DC37-4587-87C2-17AE81D96818}" type="datetimeFigureOut">
              <a:rPr lang="en-US" smtClean="0"/>
              <a:t>5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AA87E-718E-4183-B2A6-27F50425D9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91550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55877F-DC37-4587-87C2-17AE81D96818}" type="datetimeFigureOut">
              <a:rPr lang="en-US" smtClean="0"/>
              <a:t>5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AA87E-718E-4183-B2A6-27F50425D9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400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55877F-DC37-4587-87C2-17AE81D96818}" type="datetimeFigureOut">
              <a:rPr lang="en-US" smtClean="0"/>
              <a:t>5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AA87E-718E-4183-B2A6-27F50425D9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70007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55877F-DC37-4587-87C2-17AE81D96818}" type="datetimeFigureOut">
              <a:rPr lang="en-US" smtClean="0"/>
              <a:t>5/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AA87E-718E-4183-B2A6-27F50425D9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53716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55877F-DC37-4587-87C2-17AE81D96818}" type="datetimeFigureOut">
              <a:rPr lang="en-US" smtClean="0"/>
              <a:t>5/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AA87E-718E-4183-B2A6-27F50425D9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90068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55877F-DC37-4587-87C2-17AE81D96818}" type="datetimeFigureOut">
              <a:rPr lang="en-US" smtClean="0"/>
              <a:t>5/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AA87E-718E-4183-B2A6-27F50425D9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45203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55877F-DC37-4587-87C2-17AE81D96818}" type="datetimeFigureOut">
              <a:rPr lang="en-US" smtClean="0"/>
              <a:t>5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AA87E-718E-4183-B2A6-27F50425D9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57392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55877F-DC37-4587-87C2-17AE81D96818}" type="datetimeFigureOut">
              <a:rPr lang="en-US" smtClean="0"/>
              <a:t>5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AA87E-718E-4183-B2A6-27F50425D9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91473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55877F-DC37-4587-87C2-17AE81D96818}" type="datetimeFigureOut">
              <a:rPr lang="en-US" smtClean="0"/>
              <a:t>5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8AA87E-718E-4183-B2A6-27F50425D9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95871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Table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84549769"/>
              </p:ext>
            </p:extLst>
          </p:nvPr>
        </p:nvGraphicFramePr>
        <p:xfrm>
          <a:off x="1343212" y="1540482"/>
          <a:ext cx="9398000" cy="1828800"/>
        </p:xfrm>
        <a:graphic>
          <a:graphicData uri="http://schemas.openxmlformats.org/drawingml/2006/table">
            <a:tbl>
              <a:tblPr firstRow="1" bandRow="1"/>
              <a:tblGrid>
                <a:gridCol w="2349500">
                  <a:extLst>
                    <a:ext uri="{9D8B030D-6E8A-4147-A177-3AD203B41FA5}">
                      <a16:colId xmlns:a16="http://schemas.microsoft.com/office/drawing/2014/main" val="2254087190"/>
                    </a:ext>
                  </a:extLst>
                </a:gridCol>
                <a:gridCol w="2349500">
                  <a:extLst>
                    <a:ext uri="{9D8B030D-6E8A-4147-A177-3AD203B41FA5}">
                      <a16:colId xmlns:a16="http://schemas.microsoft.com/office/drawing/2014/main" val="1180516582"/>
                    </a:ext>
                  </a:extLst>
                </a:gridCol>
                <a:gridCol w="2349500">
                  <a:extLst>
                    <a:ext uri="{9D8B030D-6E8A-4147-A177-3AD203B41FA5}">
                      <a16:colId xmlns:a16="http://schemas.microsoft.com/office/drawing/2014/main" val="1247339581"/>
                    </a:ext>
                  </a:extLst>
                </a:gridCol>
                <a:gridCol w="2349500">
                  <a:extLst>
                    <a:ext uri="{9D8B030D-6E8A-4147-A177-3AD203B41FA5}">
                      <a16:colId xmlns:a16="http://schemas.microsoft.com/office/drawing/2014/main" val="2106835241"/>
                    </a:ext>
                  </a:extLst>
                </a:gridCol>
              </a:tblGrid>
              <a:tr h="304800"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ndida rugos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ndida mesorugos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ryptococcus magnu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75608022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sembly size (Mb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.9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.6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6.6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90239208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ig number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8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04381678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/L50 (Mb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/3.2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/3.6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2/0.8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80606120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mplete BUSCO (%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2.3 (n</a:t>
                      </a:r>
                      <a:r>
                        <a:rPr lang="en-US" sz="18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=</a:t>
                      </a:r>
                      <a:r>
                        <a:rPr lang="en-US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59)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1.6 (n</a:t>
                      </a:r>
                      <a:r>
                        <a:rPr lang="en-US" sz="18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=</a:t>
                      </a:r>
                      <a:r>
                        <a:rPr lang="en-US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59)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7.6 (n</a:t>
                      </a:r>
                      <a:r>
                        <a:rPr lang="en-US" sz="18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=1335</a:t>
                      </a:r>
                      <a:r>
                        <a:rPr lang="en-US" sz="1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)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0995240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algn="l" fontAlgn="t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ing BUSCO (%)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31566029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255289" y="762267"/>
            <a:ext cx="9398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Table </a:t>
            </a:r>
            <a:r>
              <a:rPr lang="en-US" dirty="0" smtClean="0"/>
              <a:t>S2. </a:t>
            </a:r>
            <a:r>
              <a:rPr lang="en-US" dirty="0" smtClean="0"/>
              <a:t>Assembly statistics of the draft genomes of </a:t>
            </a:r>
            <a:r>
              <a:rPr lang="en-US" i="1" dirty="0" smtClean="0"/>
              <a:t>Candida </a:t>
            </a:r>
            <a:r>
              <a:rPr lang="en-US" i="1" dirty="0" err="1" smtClean="0"/>
              <a:t>rugosa</a:t>
            </a:r>
            <a:r>
              <a:rPr lang="en-US" dirty="0" smtClean="0"/>
              <a:t>, </a:t>
            </a:r>
            <a:r>
              <a:rPr lang="en-US" i="1" dirty="0" smtClean="0"/>
              <a:t>Candida </a:t>
            </a:r>
            <a:r>
              <a:rPr lang="en-US" i="1" dirty="0" err="1" smtClean="0"/>
              <a:t>mesorugosa</a:t>
            </a:r>
            <a:r>
              <a:rPr lang="en-US" i="1" dirty="0" smtClean="0"/>
              <a:t> </a:t>
            </a:r>
            <a:r>
              <a:rPr lang="en-US" dirty="0" smtClean="0"/>
              <a:t>and </a:t>
            </a:r>
            <a:r>
              <a:rPr lang="en-US" i="1" dirty="0" smtClean="0"/>
              <a:t>Cryptococcus </a:t>
            </a:r>
            <a:r>
              <a:rPr lang="en-US" i="1" dirty="0" err="1" smtClean="0"/>
              <a:t>magnus</a:t>
            </a:r>
            <a:r>
              <a:rPr lang="en-US" i="1" dirty="0"/>
              <a:t> </a:t>
            </a:r>
            <a:r>
              <a:rPr lang="en-US" dirty="0" smtClean="0"/>
              <a:t>in the mock fungal community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661903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1EF7C38FBB09E4F85BDAAA01A857FC3" ma:contentTypeVersion="13" ma:contentTypeDescription="Create a new document." ma:contentTypeScope="" ma:versionID="462a9eb004de65fad2727f7b025d74ed">
  <xsd:schema xmlns:xsd="http://www.w3.org/2001/XMLSchema" xmlns:xs="http://www.w3.org/2001/XMLSchema" xmlns:p="http://schemas.microsoft.com/office/2006/metadata/properties" xmlns:ns3="a0cf5225-6064-4702-9e25-e106cea4ec30" xmlns:ns4="75e521d4-4013-45d9-ac7e-9eb842c0f228" targetNamespace="http://schemas.microsoft.com/office/2006/metadata/properties" ma:root="true" ma:fieldsID="385c780b75cbf956706aadcb38b7f192" ns3:_="" ns4:_="">
    <xsd:import namespace="a0cf5225-6064-4702-9e25-e106cea4ec30"/>
    <xsd:import namespace="75e521d4-4013-45d9-ac7e-9eb842c0f228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Tags" minOccurs="0"/>
                <xsd:element ref="ns4:MediaServiceOCR" minOccurs="0"/>
                <xsd:element ref="ns4:MediaServiceAutoKeyPoints" minOccurs="0"/>
                <xsd:element ref="ns4:MediaServiceKeyPoints" minOccurs="0"/>
                <xsd:element ref="ns4:MediaServiceGenerationTime" minOccurs="0"/>
                <xsd:element ref="ns4:MediaServiceEventHashCode" minOccurs="0"/>
                <xsd:element ref="ns4:MediaServiceDateTaken" minOccurs="0"/>
                <xsd:element ref="ns4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0cf5225-6064-4702-9e25-e106cea4ec30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5e521d4-4013-45d9-ac7e-9eb842c0f228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MediaServiceAutoTags" ma:internalName="MediaServiceAutoTags" ma:readOnly="true">
      <xsd:simpleType>
        <xsd:restriction base="dms:Text"/>
      </xsd:simpleType>
    </xsd:element>
    <xsd:element name="MediaServiceOCR" ma:index="14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AutoKeyPoints" ma:index="15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6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9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05B68EE0-6D66-4E4F-9832-33DF095A5149}">
  <ds:schemaRefs>
    <ds:schemaRef ds:uri="75e521d4-4013-45d9-ac7e-9eb842c0f228"/>
    <ds:schemaRef ds:uri="http://purl.org/dc/terms/"/>
    <ds:schemaRef ds:uri="http://schemas.microsoft.com/office/2006/metadata/properties"/>
    <ds:schemaRef ds:uri="http://schemas.openxmlformats.org/package/2006/metadata/core-properties"/>
    <ds:schemaRef ds:uri="http://schemas.microsoft.com/office/2006/documentManagement/types"/>
    <ds:schemaRef ds:uri="http://purl.org/dc/dcmitype/"/>
    <ds:schemaRef ds:uri="http://purl.org/dc/elements/1.1/"/>
    <ds:schemaRef ds:uri="http://schemas.microsoft.com/office/infopath/2007/PartnerControls"/>
    <ds:schemaRef ds:uri="a0cf5225-6064-4702-9e25-e106cea4ec30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AD524537-29CA-40FE-A861-150A6B220F1C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48560677-9286-4B62-8C53-F9FC82782BD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0cf5225-6064-4702-9e25-e106cea4ec30"/>
    <ds:schemaRef ds:uri="75e521d4-4013-45d9-ac7e-9eb842c0f22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44</TotalTime>
  <Words>73</Words>
  <Application>Microsoft Office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Benchmarking community composition  using gold standard analysis</dc:title>
  <dc:creator>Yiheng Hu</dc:creator>
  <cp:lastModifiedBy>Yiheng Hu</cp:lastModifiedBy>
  <cp:revision>10</cp:revision>
  <dcterms:created xsi:type="dcterms:W3CDTF">2021-03-24T13:25:26Z</dcterms:created>
  <dcterms:modified xsi:type="dcterms:W3CDTF">2021-05-01T21:55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1EF7C38FBB09E4F85BDAAA01A857FC3</vt:lpwstr>
  </property>
</Properties>
</file>